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0" r:id="rId2"/>
  </p:sldIdLst>
  <p:sldSz cx="6858000" cy="9144000" type="screen4x3"/>
  <p:notesSz cx="6797675" cy="987425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3371" autoAdjust="0"/>
  </p:normalViewPr>
  <p:slideViewPr>
    <p:cSldViewPr>
      <p:cViewPr>
        <p:scale>
          <a:sx n="98" d="100"/>
          <a:sy n="98" d="100"/>
        </p:scale>
        <p:origin x="-2856" y="-72"/>
      </p:cViewPr>
      <p:guideLst>
        <p:guide orient="horz" pos="2880"/>
        <p:guide pos="845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371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49688" y="0"/>
            <a:ext cx="2946400" cy="49371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F55FBCD-D318-4371-8053-EFBBC77DAA6F}" type="datetimeFigureOut">
              <a:rPr lang="en-GB" smtClean="0"/>
              <a:t>19/11/2019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009775" y="741363"/>
            <a:ext cx="2778125" cy="37020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450" y="4691063"/>
            <a:ext cx="5438775" cy="4443412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378950"/>
            <a:ext cx="2946400" cy="4937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49688" y="9378950"/>
            <a:ext cx="2946400" cy="4937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D6EA6F4-1D04-4C20-A904-748DDB3FEE3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191158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009775" y="741363"/>
            <a:ext cx="2778125" cy="370205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0D6EA6F4-1D04-4C20-A904-748DDB3FEE3B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0130856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73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74DC34-1A03-4429-9567-0C3B51E52AC9}" type="datetimeFigureOut">
              <a:rPr lang="en-GB" smtClean="0"/>
              <a:t>19/11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16D1AB-4FA5-43CE-AC07-9BAEEE98885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7436243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74DC34-1A03-4429-9567-0C3B51E52AC9}" type="datetimeFigureOut">
              <a:rPr lang="en-GB" smtClean="0"/>
              <a:t>19/11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16D1AB-4FA5-43CE-AC07-9BAEEE98885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0676277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9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9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74DC34-1A03-4429-9567-0C3B51E52AC9}" type="datetimeFigureOut">
              <a:rPr lang="en-GB" smtClean="0"/>
              <a:t>19/11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16D1AB-4FA5-43CE-AC07-9BAEEE98885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8599344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74DC34-1A03-4429-9567-0C3B51E52AC9}" type="datetimeFigureOut">
              <a:rPr lang="en-GB" smtClean="0"/>
              <a:t>19/11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16D1AB-4FA5-43CE-AC07-9BAEEE98885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1243688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24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74DC34-1A03-4429-9567-0C3B51E52AC9}" type="datetimeFigureOut">
              <a:rPr lang="en-GB" smtClean="0"/>
              <a:t>19/11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16D1AB-4FA5-43CE-AC07-9BAEEE98885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8925011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6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6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74DC34-1A03-4429-9567-0C3B51E52AC9}" type="datetimeFigureOut">
              <a:rPr lang="en-GB" smtClean="0"/>
              <a:t>19/11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16D1AB-4FA5-43CE-AC07-9BAEEE98885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9091057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2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2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73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73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74DC34-1A03-4429-9567-0C3B51E52AC9}" type="datetimeFigureOut">
              <a:rPr lang="en-GB" smtClean="0"/>
              <a:t>19/11/2019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16D1AB-4FA5-43CE-AC07-9BAEEE98885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9138105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74DC34-1A03-4429-9567-0C3B51E52AC9}" type="datetimeFigureOut">
              <a:rPr lang="en-GB" smtClean="0"/>
              <a:t>19/11/2019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16D1AB-4FA5-43CE-AC07-9BAEEE98885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431585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74DC34-1A03-4429-9567-0C3B51E52AC9}" type="datetimeFigureOut">
              <a:rPr lang="en-GB" smtClean="0"/>
              <a:t>19/11/2019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16D1AB-4FA5-43CE-AC07-9BAEEE98885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2296639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4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91" y="364073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4" y="1913473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74DC34-1A03-4429-9567-0C3B51E52AC9}" type="datetimeFigureOut">
              <a:rPr lang="en-GB" smtClean="0"/>
              <a:t>19/11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16D1AB-4FA5-43CE-AC07-9BAEEE98885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3421675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74DC34-1A03-4429-9567-0C3B51E52AC9}" type="datetimeFigureOut">
              <a:rPr lang="en-GB" smtClean="0"/>
              <a:t>19/11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16D1AB-4FA5-43CE-AC07-9BAEEE98885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235840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6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40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874DC34-1A03-4429-9567-0C3B51E52AC9}" type="datetimeFigureOut">
              <a:rPr lang="en-GB" smtClean="0"/>
              <a:t>19/11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40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40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F16D1AB-4FA5-43CE-AC07-9BAEEE98885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314807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emf"/><Relationship Id="rId3" Type="http://schemas.openxmlformats.org/officeDocument/2006/relationships/image" Target="../media/image1.emf"/><Relationship Id="rId7" Type="http://schemas.openxmlformats.org/officeDocument/2006/relationships/image" Target="../media/image5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emf"/><Relationship Id="rId5" Type="http://schemas.openxmlformats.org/officeDocument/2006/relationships/image" Target="../media/image3.emf"/><Relationship Id="rId4" Type="http://schemas.openxmlformats.org/officeDocument/2006/relationships/image" Target="../media/image2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8" name="Group 17"/>
          <p:cNvGrpSpPr/>
          <p:nvPr/>
        </p:nvGrpSpPr>
        <p:grpSpPr>
          <a:xfrm>
            <a:off x="2263455" y="3681792"/>
            <a:ext cx="2632192" cy="2215213"/>
            <a:chOff x="3521067" y="1309786"/>
            <a:chExt cx="2632192" cy="2215213"/>
          </a:xfrm>
        </p:grpSpPr>
        <p:grpSp>
          <p:nvGrpSpPr>
            <p:cNvPr id="16" name="Group 15"/>
            <p:cNvGrpSpPr/>
            <p:nvPr/>
          </p:nvGrpSpPr>
          <p:grpSpPr>
            <a:xfrm>
              <a:off x="3698602" y="1309786"/>
              <a:ext cx="2454657" cy="1995259"/>
              <a:chOff x="3698602" y="1309786"/>
              <a:chExt cx="2454657" cy="1995259"/>
            </a:xfrm>
          </p:grpSpPr>
          <p:pic>
            <p:nvPicPr>
              <p:cNvPr id="4176" name="Picture 80"/>
              <p:cNvPicPr>
                <a:picLocks noChangeAspect="1" noChangeArrowheads="1"/>
              </p:cNvPicPr>
              <p:nvPr/>
            </p:nvPicPr>
            <p:blipFill rotWithShape="1"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8492" r="23249" b="10312"/>
              <a:stretch/>
            </p:blipFill>
            <p:spPr bwMode="auto">
              <a:xfrm>
                <a:off x="3698602" y="1309786"/>
                <a:ext cx="2315112" cy="1995259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grpSp>
            <p:nvGrpSpPr>
              <p:cNvPr id="13" name="Group 12"/>
              <p:cNvGrpSpPr/>
              <p:nvPr/>
            </p:nvGrpSpPr>
            <p:grpSpPr>
              <a:xfrm>
                <a:off x="5313091" y="1412424"/>
                <a:ext cx="840168" cy="450422"/>
                <a:chOff x="5313091" y="1412424"/>
                <a:chExt cx="840168" cy="450422"/>
              </a:xfrm>
            </p:grpSpPr>
            <p:pic>
              <p:nvPicPr>
                <p:cNvPr id="4178" name="Picture 82"/>
                <p:cNvPicPr>
                  <a:picLocks noChangeAspect="1" noChangeArrowheads="1"/>
                </p:cNvPicPr>
                <p:nvPr/>
              </p:nvPicPr>
              <p:blipFill rotWithShape="1">
                <a:blip r:embed="rId4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81659" t="5648" r="12002" b="80554"/>
                <a:stretch/>
              </p:blipFill>
              <p:spPr bwMode="auto">
                <a:xfrm>
                  <a:off x="5313091" y="1434829"/>
                  <a:ext cx="299767" cy="428017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</p:pic>
            <p:sp>
              <p:nvSpPr>
                <p:cNvPr id="12" name="TextBox 11"/>
                <p:cNvSpPr txBox="1"/>
                <p:nvPr/>
              </p:nvSpPr>
              <p:spPr>
                <a:xfrm>
                  <a:off x="5481280" y="1412424"/>
                  <a:ext cx="671979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800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SF3B1</a:t>
                  </a:r>
                  <a:r>
                    <a:rPr lang="en-GB" sz="800" baseline="30000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K700K</a:t>
                  </a:r>
                  <a:endParaRPr lang="en-GB" sz="800" baseline="300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1" name="TextBox 20"/>
                <p:cNvSpPr txBox="1"/>
                <p:nvPr/>
              </p:nvSpPr>
              <p:spPr>
                <a:xfrm>
                  <a:off x="5487760" y="1620252"/>
                  <a:ext cx="66396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800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SF3B1</a:t>
                  </a:r>
                  <a:r>
                    <a:rPr lang="en-GB" sz="800" baseline="30000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K700E</a:t>
                  </a:r>
                  <a:endParaRPr lang="en-GB" sz="800" baseline="300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</p:grpSp>
        <p:sp>
          <p:nvSpPr>
            <p:cNvPr id="24" name="TextBox 23"/>
            <p:cNvSpPr txBox="1"/>
            <p:nvPr/>
          </p:nvSpPr>
          <p:spPr>
            <a:xfrm rot="16200000">
              <a:off x="3062924" y="2116259"/>
              <a:ext cx="113172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% of viable cells</a:t>
              </a:r>
              <a:endParaRPr lang="en-GB" sz="8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" name="TextBox 24"/>
            <p:cNvSpPr txBox="1"/>
            <p:nvPr/>
          </p:nvSpPr>
          <p:spPr>
            <a:xfrm>
              <a:off x="4376600" y="3309555"/>
              <a:ext cx="107273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og KU-55933 (</a:t>
              </a:r>
              <a:r>
                <a:rPr lang="el-GR" sz="8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μ</a:t>
              </a:r>
              <a:r>
                <a:rPr lang="en-GB" sz="8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)</a:t>
              </a:r>
              <a:endParaRPr lang="en-GB" sz="8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20" name="Group 19"/>
          <p:cNvGrpSpPr/>
          <p:nvPr/>
        </p:nvGrpSpPr>
        <p:grpSpPr>
          <a:xfrm>
            <a:off x="329328" y="861285"/>
            <a:ext cx="2874343" cy="2287461"/>
            <a:chOff x="329324" y="1218079"/>
            <a:chExt cx="2874343" cy="2287461"/>
          </a:xfrm>
        </p:grpSpPr>
        <p:pic>
          <p:nvPicPr>
            <p:cNvPr id="4179" name="Picture 83"/>
            <p:cNvPicPr>
              <a:picLocks noChangeAspect="1" noChangeArrowheads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351" r="29739" b="11610"/>
            <a:stretch/>
          </p:blipFill>
          <p:spPr bwMode="auto">
            <a:xfrm>
              <a:off x="476672" y="1218079"/>
              <a:ext cx="2248755" cy="2120313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29" name="TextBox 28"/>
            <p:cNvSpPr txBox="1"/>
            <p:nvPr/>
          </p:nvSpPr>
          <p:spPr>
            <a:xfrm rot="16200000">
              <a:off x="-128819" y="2086016"/>
              <a:ext cx="113172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% of viable cells</a:t>
              </a:r>
              <a:endParaRPr lang="en-GB" sz="8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" name="TextBox 29"/>
            <p:cNvSpPr txBox="1"/>
            <p:nvPr/>
          </p:nvSpPr>
          <p:spPr>
            <a:xfrm>
              <a:off x="1144200" y="3290096"/>
              <a:ext cx="958917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og VE-821 (</a:t>
              </a:r>
              <a:r>
                <a:rPr lang="el-GR" sz="8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μ</a:t>
              </a:r>
              <a:r>
                <a:rPr lang="en-GB" sz="8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)</a:t>
              </a:r>
              <a:endParaRPr lang="en-GB" sz="8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19" name="Group 18"/>
            <p:cNvGrpSpPr/>
            <p:nvPr/>
          </p:nvGrpSpPr>
          <p:grpSpPr>
            <a:xfrm>
              <a:off x="2318393" y="1412424"/>
              <a:ext cx="885274" cy="459397"/>
              <a:chOff x="2318393" y="1412424"/>
              <a:chExt cx="885274" cy="459397"/>
            </a:xfrm>
          </p:grpSpPr>
          <p:pic>
            <p:nvPicPr>
              <p:cNvPr id="4180" name="Picture 84"/>
              <p:cNvPicPr>
                <a:picLocks noChangeAspect="1" noChangeArrowheads="1"/>
              </p:cNvPicPr>
              <p:nvPr/>
            </p:nvPicPr>
            <p:blipFill rotWithShape="1">
              <a:blip r:embed="rId6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77008" t="4655" r="14640" b="80176"/>
              <a:stretch/>
            </p:blipFill>
            <p:spPr bwMode="auto">
              <a:xfrm>
                <a:off x="2318393" y="1444401"/>
                <a:ext cx="350693" cy="427420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sp>
            <p:nvSpPr>
              <p:cNvPr id="32" name="TextBox 31"/>
              <p:cNvSpPr txBox="1"/>
              <p:nvPr/>
            </p:nvSpPr>
            <p:spPr>
              <a:xfrm>
                <a:off x="2531688" y="1412424"/>
                <a:ext cx="671979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8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F3B1</a:t>
                </a:r>
                <a:r>
                  <a:rPr lang="en-GB" sz="800" baseline="300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K700K</a:t>
                </a:r>
                <a:endParaRPr lang="en-GB" sz="800" baseline="300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3" name="TextBox 32"/>
              <p:cNvSpPr txBox="1"/>
              <p:nvPr/>
            </p:nvSpPr>
            <p:spPr>
              <a:xfrm>
                <a:off x="2538168" y="1620252"/>
                <a:ext cx="66396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8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F3B1</a:t>
                </a:r>
                <a:r>
                  <a:rPr lang="en-GB" sz="800" baseline="300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K700E</a:t>
                </a:r>
                <a:endParaRPr lang="en-GB" sz="800" baseline="300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</p:grpSp>
      <p:grpSp>
        <p:nvGrpSpPr>
          <p:cNvPr id="22" name="Group 21"/>
          <p:cNvGrpSpPr/>
          <p:nvPr/>
        </p:nvGrpSpPr>
        <p:grpSpPr>
          <a:xfrm>
            <a:off x="3615080" y="768320"/>
            <a:ext cx="2859621" cy="2339617"/>
            <a:chOff x="408561" y="4259563"/>
            <a:chExt cx="2859621" cy="2339618"/>
          </a:xfrm>
        </p:grpSpPr>
        <p:grpSp>
          <p:nvGrpSpPr>
            <p:cNvPr id="3" name="Group 2"/>
            <p:cNvGrpSpPr/>
            <p:nvPr/>
          </p:nvGrpSpPr>
          <p:grpSpPr>
            <a:xfrm>
              <a:off x="408561" y="4265271"/>
              <a:ext cx="2430194" cy="2333910"/>
              <a:chOff x="422659" y="3963395"/>
              <a:chExt cx="2498738" cy="2639043"/>
            </a:xfrm>
          </p:grpSpPr>
          <p:pic>
            <p:nvPicPr>
              <p:cNvPr id="4174" name="Picture 78"/>
              <p:cNvPicPr>
                <a:picLocks noChangeAspect="1" noChangeArrowheads="1"/>
              </p:cNvPicPr>
              <p:nvPr/>
            </p:nvPicPr>
            <p:blipFill rotWithShape="1">
              <a:blip r:embed="rId7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9223" r="37272" b="9202"/>
              <a:stretch/>
            </p:blipFill>
            <p:spPr bwMode="auto">
              <a:xfrm>
                <a:off x="620688" y="3963395"/>
                <a:ext cx="2300709" cy="2415595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sp>
            <p:nvSpPr>
              <p:cNvPr id="14" name="TextBox 13"/>
              <p:cNvSpPr txBox="1"/>
              <p:nvPr/>
            </p:nvSpPr>
            <p:spPr>
              <a:xfrm>
                <a:off x="1277958" y="6358827"/>
                <a:ext cx="1013982" cy="24361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8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og UCN-01 (</a:t>
                </a:r>
                <a:r>
                  <a:rPr lang="en-GB" sz="800" b="1" dirty="0" err="1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M</a:t>
                </a:r>
                <a:r>
                  <a:rPr lang="en-GB" sz="8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)</a:t>
                </a:r>
                <a:endParaRPr lang="en-GB" sz="8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" name="TextBox 14"/>
              <p:cNvSpPr txBox="1"/>
              <p:nvPr/>
            </p:nvSpPr>
            <p:spPr>
              <a:xfrm rot="16200000">
                <a:off x="-106425" y="4985094"/>
                <a:ext cx="1279690" cy="2215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8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% of viable cells</a:t>
                </a:r>
                <a:endParaRPr lang="en-GB" sz="8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pic>
          <p:nvPicPr>
            <p:cNvPr id="4181" name="Picture 85"/>
            <p:cNvPicPr>
              <a:picLocks noChangeAspect="1" noChangeArrowheads="1"/>
            </p:cNvPicPr>
            <p:nvPr/>
          </p:nvPicPr>
          <p:blipFill rotWithShape="1"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7527" t="2667" r="25812" b="78953"/>
            <a:stretch/>
          </p:blipFill>
          <p:spPr bwMode="auto">
            <a:xfrm>
              <a:off x="1990377" y="4260773"/>
              <a:ext cx="396026" cy="676072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37" name="TextBox 36"/>
            <p:cNvSpPr txBox="1"/>
            <p:nvPr/>
          </p:nvSpPr>
          <p:spPr>
            <a:xfrm>
              <a:off x="2213085" y="4259563"/>
              <a:ext cx="785793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F3B1</a:t>
              </a:r>
              <a:r>
                <a:rPr lang="en-GB" sz="800" baseline="30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K700K-EV</a:t>
              </a:r>
              <a:endParaRPr lang="en-GB" sz="800" baseline="30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8" name="TextBox 37"/>
            <p:cNvSpPr txBox="1"/>
            <p:nvPr/>
          </p:nvSpPr>
          <p:spPr>
            <a:xfrm>
              <a:off x="2219565" y="4467391"/>
              <a:ext cx="777777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F3B1</a:t>
              </a:r>
              <a:r>
                <a:rPr lang="en-GB" sz="800" baseline="30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K700E-EV</a:t>
              </a:r>
              <a:endParaRPr lang="en-GB" sz="800" baseline="30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9" name="TextBox 38"/>
            <p:cNvSpPr txBox="1"/>
            <p:nvPr/>
          </p:nvSpPr>
          <p:spPr>
            <a:xfrm>
              <a:off x="2221100" y="4688290"/>
              <a:ext cx="1047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F3B1</a:t>
              </a:r>
              <a:r>
                <a:rPr lang="en-GB" sz="800" baseline="30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K700E-RNaseH-WT</a:t>
              </a:r>
              <a:endParaRPr lang="en-GB" sz="800" baseline="30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112" name="TextBox 111"/>
          <p:cNvSpPr txBox="1"/>
          <p:nvPr/>
        </p:nvSpPr>
        <p:spPr>
          <a:xfrm>
            <a:off x="366551" y="583655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</a:p>
        </p:txBody>
      </p:sp>
      <p:sp>
        <p:nvSpPr>
          <p:cNvPr id="113" name="TextBox 112"/>
          <p:cNvSpPr txBox="1"/>
          <p:nvPr/>
        </p:nvSpPr>
        <p:spPr>
          <a:xfrm>
            <a:off x="3415005" y="551388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en-GB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4" name="TextBox 113"/>
          <p:cNvSpPr txBox="1"/>
          <p:nvPr/>
        </p:nvSpPr>
        <p:spPr>
          <a:xfrm>
            <a:off x="2264989" y="3433514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en-GB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1" name="TextBox 80"/>
          <p:cNvSpPr txBox="1"/>
          <p:nvPr/>
        </p:nvSpPr>
        <p:spPr>
          <a:xfrm>
            <a:off x="188640" y="139463"/>
            <a:ext cx="72808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Fig S6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66161649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1297</TotalTime>
  <Words>42</Words>
  <Application>Microsoft Office PowerPoint</Application>
  <PresentationFormat>On-screen Show (4:3)</PresentationFormat>
  <Paragraphs>18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University of Oxford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halini Singh</dc:creator>
  <cp:lastModifiedBy>andreap</cp:lastModifiedBy>
  <cp:revision>291</cp:revision>
  <cp:lastPrinted>2019-11-10T17:33:11Z</cp:lastPrinted>
  <dcterms:created xsi:type="dcterms:W3CDTF">2019-09-05T11:00:27Z</dcterms:created>
  <dcterms:modified xsi:type="dcterms:W3CDTF">2019-11-19T14:13:32Z</dcterms:modified>
</cp:coreProperties>
</file>